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8" r:id="rId4"/>
    <p:sldId id="261" r:id="rId5"/>
    <p:sldId id="259" r:id="rId6"/>
    <p:sldId id="262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020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tiff"/><Relationship Id="rId4" Type="http://schemas.openxmlformats.org/officeDocument/2006/relationships/image" Target="../media/image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6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E:\chen panpan\2013-8-16\ACTIN\SMA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94" t="30698" r="18708" b="29183"/>
          <a:stretch/>
        </p:blipFill>
        <p:spPr bwMode="auto">
          <a:xfrm rot="180000" flipH="1">
            <a:off x="1114163" y="1257493"/>
            <a:ext cx="7573188" cy="3037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E:\chen panpan\2013-8-16\ACTIN\ACTIN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3" t="19696" r="18611" b="39422"/>
          <a:stretch/>
        </p:blipFill>
        <p:spPr bwMode="auto">
          <a:xfrm rot="180000" flipH="1">
            <a:off x="1122240" y="3897958"/>
            <a:ext cx="7839226" cy="31444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40140" y="304378"/>
            <a:ext cx="61040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Raw Data for Figure 1 C</a:t>
            </a:r>
            <a:endParaRPr lang="zh-CN" altLang="en-US" sz="2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51520" y="2987660"/>
            <a:ext cx="15128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dirty="0" smtClean="0"/>
              <a:t>α</a:t>
            </a:r>
            <a:r>
              <a:rPr lang="en-US" altLang="zh-CN" dirty="0" smtClean="0"/>
              <a:t>-SMA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95536" y="5579948"/>
            <a:ext cx="1224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dirty="0" smtClean="0"/>
              <a:t>β</a:t>
            </a:r>
            <a:r>
              <a:rPr lang="en-US" altLang="zh-CN" dirty="0" smtClean="0"/>
              <a:t>-actin</a:t>
            </a:r>
            <a:endParaRPr lang="zh-CN" alt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252909" y="908720"/>
            <a:ext cx="10067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Sample</a:t>
            </a:r>
          </a:p>
          <a:p>
            <a:r>
              <a:rPr lang="en-US" altLang="zh-CN" sz="1600" b="1" dirty="0"/>
              <a:t>name</a:t>
            </a:r>
            <a:endParaRPr lang="zh-CN" altLang="en-US" sz="1600" b="1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4405003"/>
              </p:ext>
            </p:extLst>
          </p:nvPr>
        </p:nvGraphicFramePr>
        <p:xfrm>
          <a:off x="1259632" y="960186"/>
          <a:ext cx="7344000" cy="5181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</a:tblGrid>
              <a:tr h="483747"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Marker1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dirty="0" smtClean="0"/>
                        <a:t>Marker2</a:t>
                      </a:r>
                      <a:endParaRPr lang="zh-CN" altLang="en-US" sz="1400" b="1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N-CF1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N-CF2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N-CF3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H-CF1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H-CF2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H-CF3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TGF-β-1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dirty="0" smtClean="0"/>
                        <a:t>TGF-β-2</a:t>
                      </a:r>
                      <a:endParaRPr lang="zh-CN" altLang="en-US" sz="1400" b="1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dirty="0" smtClean="0"/>
                        <a:t>TGF-β-3</a:t>
                      </a:r>
                      <a:endParaRPr lang="zh-CN" altLang="en-US" sz="1400" b="1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dirty="0" smtClean="0"/>
                        <a:t>Marker3</a:t>
                      </a:r>
                      <a:endParaRPr lang="zh-CN" altLang="en-US" sz="1400" b="1" dirty="0" smtClean="0">
                        <a:latin typeface="+mn-lt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897740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lice\Desktop\letter to editor\Figure1C\SMA ACTIN analysis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6" y="692696"/>
            <a:ext cx="7471072" cy="40013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alice\Desktop\letter to editor\Figure1C\figures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1800" y="4483113"/>
            <a:ext cx="2376264" cy="23463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17444" y="116632"/>
            <a:ext cx="61040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Figure 1 C  statistic data and bar figure</a:t>
            </a:r>
            <a:endParaRPr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902028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lice\Desktop\纤维化数据整理\2013-8-13 FIGURE1D ACTIN\CRCCHEMIDOC 2013-08-13 15 时 43 分_Exposure_4.0sec actin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80" t="22632" r="10818" b="32343"/>
          <a:stretch/>
        </p:blipFill>
        <p:spPr bwMode="auto">
          <a:xfrm>
            <a:off x="1331640" y="3500264"/>
            <a:ext cx="7632848" cy="18729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alice\Desktop\纤维化数据整理\2013-8-20-P-SMAD  FIGURE1D FIGURE1F\collagen &amp; marker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26" t="16710" r="4000" b="67520"/>
          <a:stretch/>
        </p:blipFill>
        <p:spPr bwMode="auto">
          <a:xfrm>
            <a:off x="1331640" y="2157165"/>
            <a:ext cx="7450619" cy="10558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24916" y="519063"/>
            <a:ext cx="39590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Raw Data for Figure1 </a:t>
            </a:r>
            <a:r>
              <a:rPr lang="en-US" altLang="zh-CN" sz="2400" b="1" dirty="0" smtClean="0"/>
              <a:t>D</a:t>
            </a:r>
            <a:endParaRPr lang="zh-CN" altLang="en-US" sz="2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23528" y="2420888"/>
            <a:ext cx="11047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ollagen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98857" y="4355812"/>
            <a:ext cx="1032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dirty="0" smtClean="0"/>
              <a:t>β</a:t>
            </a:r>
            <a:r>
              <a:rPr lang="en-US" altLang="zh-CN" dirty="0" smtClean="0"/>
              <a:t>-actin</a:t>
            </a:r>
            <a:endParaRPr lang="zh-CN" altLang="en-US" dirty="0"/>
          </a:p>
        </p:txBody>
      </p:sp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7240296"/>
              </p:ext>
            </p:extLst>
          </p:nvPr>
        </p:nvGraphicFramePr>
        <p:xfrm>
          <a:off x="1403648" y="1468007"/>
          <a:ext cx="7344000" cy="5181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  <a:gridCol w="612000"/>
              </a:tblGrid>
              <a:tr h="478052"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Marker1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dirty="0" smtClean="0"/>
                        <a:t>N-CF1</a:t>
                      </a:r>
                      <a:endParaRPr lang="zh-CN" altLang="en-US" sz="1400" b="1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H-CF1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TGF-β-1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N-CF2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H-CF2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dirty="0" smtClean="0"/>
                        <a:t>TGF-β-2</a:t>
                      </a:r>
                      <a:endParaRPr lang="zh-CN" altLang="en-US" sz="1400" b="1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N-CF3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400" b="1" dirty="0" smtClean="0"/>
                        <a:t>H-CF3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dirty="0" smtClean="0"/>
                        <a:t>TGF-β-3</a:t>
                      </a:r>
                      <a:endParaRPr lang="zh-CN" altLang="en-US" sz="1400" b="1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dirty="0" smtClean="0"/>
                        <a:t>Marker2</a:t>
                      </a:r>
                      <a:endParaRPr lang="zh-CN" altLang="en-US" sz="1400" b="1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dirty="0" smtClean="0"/>
                        <a:t>Marker3</a:t>
                      </a:r>
                      <a:endParaRPr lang="zh-CN" altLang="en-US" sz="1400" b="1" dirty="0" smtClean="0">
                        <a:latin typeface="+mn-lt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324917" y="1404065"/>
            <a:ext cx="10067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Sample</a:t>
            </a:r>
          </a:p>
          <a:p>
            <a:r>
              <a:rPr lang="en-US" altLang="zh-CN" sz="1600" b="1" dirty="0"/>
              <a:t>name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37381316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lice\Desktop\letter to editor\Figure1D\collagen actin statistic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4728" y="692696"/>
            <a:ext cx="6807671" cy="36127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alice\Desktop\letter to editor\Figure1D\collagen bar figures-1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752" y="4653136"/>
            <a:ext cx="2544171" cy="19126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17444" y="116632"/>
            <a:ext cx="61040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Figure 1 D statistic data and bar figure</a:t>
            </a:r>
            <a:endParaRPr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5537717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E:\纤维化实验数据\fibrosis figures\modifiy 20140226\fig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964927"/>
            <a:ext cx="3096344" cy="56209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683567" y="260648"/>
            <a:ext cx="3667825" cy="3812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The original Figure 1 with mistakes</a:t>
            </a:r>
            <a:endParaRPr lang="zh-CN" altLang="en-US" dirty="0"/>
          </a:p>
        </p:txBody>
      </p:sp>
      <p:pic>
        <p:nvPicPr>
          <p:cNvPr id="6" name="Picture 3" descr="E:\chen panpan\2013-8-16\ACTIN\SMA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94" t="30698" r="18708" b="29183"/>
          <a:stretch/>
        </p:blipFill>
        <p:spPr bwMode="auto">
          <a:xfrm rot="180000" flipH="1">
            <a:off x="5409714" y="256200"/>
            <a:ext cx="3235008" cy="12973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" descr="E:\chen panpan\2013-8-16\ACTIN\ACTIN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3" t="19696" r="18611" b="39422"/>
          <a:stretch/>
        </p:blipFill>
        <p:spPr bwMode="auto">
          <a:xfrm rot="180000" flipH="1">
            <a:off x="5511466" y="1569632"/>
            <a:ext cx="3276855" cy="13144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458644" y="641893"/>
            <a:ext cx="9361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Figure 1C α-SMA</a:t>
            </a:r>
            <a:endParaRPr lang="zh-CN" altLang="en-US" sz="1100" dirty="0"/>
          </a:p>
        </p:txBody>
      </p:sp>
      <p:sp>
        <p:nvSpPr>
          <p:cNvPr id="9" name="TextBox 8"/>
          <p:cNvSpPr txBox="1"/>
          <p:nvPr/>
        </p:nvSpPr>
        <p:spPr>
          <a:xfrm>
            <a:off x="4441876" y="2243693"/>
            <a:ext cx="9361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Figure 1C β-actin</a:t>
            </a:r>
            <a:endParaRPr lang="zh-CN" altLang="en-US" sz="1100" dirty="0"/>
          </a:p>
        </p:txBody>
      </p:sp>
      <p:cxnSp>
        <p:nvCxnSpPr>
          <p:cNvPr id="8" name="直接箭头连接符 7"/>
          <p:cNvCxnSpPr>
            <a:stCxn id="3" idx="1"/>
          </p:cNvCxnSpPr>
          <p:nvPr/>
        </p:nvCxnSpPr>
        <p:spPr>
          <a:xfrm flipH="1">
            <a:off x="3707904" y="857337"/>
            <a:ext cx="750740" cy="242764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/>
          <p:nvPr/>
        </p:nvCxnSpPr>
        <p:spPr>
          <a:xfrm flipH="1">
            <a:off x="3756853" y="2459137"/>
            <a:ext cx="685023" cy="104131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351392" y="2924944"/>
            <a:ext cx="34969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solidFill>
                  <a:srgbClr val="FF0000"/>
                </a:solidFill>
              </a:rPr>
              <a:t>Mistake 1.  </a:t>
            </a:r>
            <a:r>
              <a:rPr lang="el-GR" altLang="zh-CN" sz="1100" dirty="0" smtClean="0">
                <a:solidFill>
                  <a:srgbClr val="FF0000"/>
                </a:solidFill>
              </a:rPr>
              <a:t>β</a:t>
            </a:r>
            <a:r>
              <a:rPr lang="en-US" altLang="zh-CN" sz="1100" dirty="0" smtClean="0">
                <a:solidFill>
                  <a:srgbClr val="FF0000"/>
                </a:solidFill>
              </a:rPr>
              <a:t>-actin in Figure 1C were reversed by mistake.  Therefore, Fig 1B was also incorrect.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pic>
        <p:nvPicPr>
          <p:cNvPr id="16" name="Picture 3" descr="C:\Users\alice\Desktop\纤维化数据整理\2013-8-20-P-SMAD  FIGURE1D FIGURE1F\collagen &amp; marker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26" t="16710" r="4000" b="67520"/>
          <a:stretch/>
        </p:blipFill>
        <p:spPr bwMode="auto">
          <a:xfrm>
            <a:off x="5631826" y="3789040"/>
            <a:ext cx="3188646" cy="4518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7" name="直接箭头连接符 16"/>
          <p:cNvCxnSpPr>
            <a:stCxn id="20" idx="1"/>
          </p:cNvCxnSpPr>
          <p:nvPr/>
        </p:nvCxnSpPr>
        <p:spPr>
          <a:xfrm flipH="1">
            <a:off x="2195738" y="4025400"/>
            <a:ext cx="2246138" cy="55572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4441876" y="3809956"/>
            <a:ext cx="9361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Figure 1D  collagen Iα1</a:t>
            </a:r>
            <a:endParaRPr lang="zh-CN" altLang="en-US" sz="1100" dirty="0"/>
          </a:p>
        </p:txBody>
      </p:sp>
      <p:pic>
        <p:nvPicPr>
          <p:cNvPr id="21" name="Picture 2" descr="E:\chen panpan\2013-8-16\ACTIN\ACTIN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3" t="19696" r="18611" b="39422"/>
          <a:stretch/>
        </p:blipFill>
        <p:spPr bwMode="auto">
          <a:xfrm flipH="1">
            <a:off x="5597583" y="4293096"/>
            <a:ext cx="3276855" cy="13144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4527993" y="4734861"/>
            <a:ext cx="8158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Figure 1C β-actin</a:t>
            </a:r>
            <a:endParaRPr lang="zh-CN" altLang="en-US" sz="1100" dirty="0"/>
          </a:p>
        </p:txBody>
      </p:sp>
      <p:cxnSp>
        <p:nvCxnSpPr>
          <p:cNvPr id="23" name="直接箭头连接符 22"/>
          <p:cNvCxnSpPr>
            <a:stCxn id="22" idx="1"/>
          </p:cNvCxnSpPr>
          <p:nvPr/>
        </p:nvCxnSpPr>
        <p:spPr>
          <a:xfrm flipH="1" flipV="1">
            <a:off x="2195737" y="4797153"/>
            <a:ext cx="2332256" cy="15315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271306" y="5418685"/>
            <a:ext cx="440515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solidFill>
                  <a:srgbClr val="FF0000"/>
                </a:solidFill>
              </a:rPr>
              <a:t>Mistake 2.  </a:t>
            </a:r>
            <a:r>
              <a:rPr lang="el-GR" altLang="zh-CN" sz="1100" dirty="0" smtClean="0">
                <a:solidFill>
                  <a:srgbClr val="FF0000"/>
                </a:solidFill>
              </a:rPr>
              <a:t>β</a:t>
            </a:r>
            <a:r>
              <a:rPr lang="en-US" altLang="zh-CN" sz="1100" dirty="0" smtClean="0">
                <a:solidFill>
                  <a:srgbClr val="FF0000"/>
                </a:solidFill>
              </a:rPr>
              <a:t>-actin in Figure 1D were mistakenly copied from Figure 1C.  Therefore, Fig 1E was also incorrect.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24" name="圆角矩形 23"/>
          <p:cNvSpPr/>
          <p:nvPr/>
        </p:nvSpPr>
        <p:spPr>
          <a:xfrm>
            <a:off x="7452320" y="4950305"/>
            <a:ext cx="792088" cy="332360"/>
          </a:xfrm>
          <a:prstGeom prst="round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Rectangle 3"/>
          <p:cNvSpPr/>
          <p:nvPr/>
        </p:nvSpPr>
        <p:spPr>
          <a:xfrm>
            <a:off x="8280412" y="49951"/>
            <a:ext cx="792088" cy="24496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圆角矩形 23"/>
          <p:cNvSpPr/>
          <p:nvPr/>
        </p:nvSpPr>
        <p:spPr>
          <a:xfrm>
            <a:off x="1547664" y="3429000"/>
            <a:ext cx="792088" cy="166180"/>
          </a:xfrm>
          <a:prstGeom prst="round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圆角矩形 23"/>
          <p:cNvSpPr/>
          <p:nvPr/>
        </p:nvSpPr>
        <p:spPr>
          <a:xfrm>
            <a:off x="1331640" y="4714062"/>
            <a:ext cx="900100" cy="166180"/>
          </a:xfrm>
          <a:prstGeom prst="round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8" name="直接箭头连接符 12"/>
          <p:cNvCxnSpPr>
            <a:endCxn id="27" idx="0"/>
          </p:cNvCxnSpPr>
          <p:nvPr/>
        </p:nvCxnSpPr>
        <p:spPr>
          <a:xfrm flipH="1">
            <a:off x="1781690" y="3595180"/>
            <a:ext cx="234974" cy="111888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07504" y="3298195"/>
            <a:ext cx="7882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solidFill>
                  <a:srgbClr val="FF0000"/>
                </a:solidFill>
              </a:rPr>
              <a:t>Mistake 1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07504" y="4665386"/>
            <a:ext cx="7882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solidFill>
                  <a:srgbClr val="FF0000"/>
                </a:solidFill>
              </a:rPr>
              <a:t>Mistake 2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862754" y="157836"/>
            <a:ext cx="9361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Raw data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40798745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alice\Desktop\letter to editor\fig1-2014-8-19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980728"/>
            <a:ext cx="3094396" cy="56166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611560" y="172435"/>
            <a:ext cx="23762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The revised Figure 1 with corrected data</a:t>
            </a:r>
            <a:endParaRPr lang="zh-CN" altLang="en-US" dirty="0"/>
          </a:p>
        </p:txBody>
      </p:sp>
      <p:pic>
        <p:nvPicPr>
          <p:cNvPr id="4" name="Picture 3" descr="E:\chen panpan\2013-8-16\ACTIN\SMA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94" t="30698" r="18708" b="29183"/>
          <a:stretch/>
        </p:blipFill>
        <p:spPr bwMode="auto">
          <a:xfrm rot="180000" flipH="1">
            <a:off x="5409714" y="256200"/>
            <a:ext cx="3235008" cy="12973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E:\chen panpan\2013-8-16\ACTIN\ACTIN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3" t="19696" r="18611" b="39422"/>
          <a:stretch/>
        </p:blipFill>
        <p:spPr bwMode="auto">
          <a:xfrm rot="180000" flipH="1">
            <a:off x="5511466" y="1801928"/>
            <a:ext cx="3276855" cy="13144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4458644" y="641893"/>
            <a:ext cx="9361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Figure 1C α-SMA</a:t>
            </a:r>
            <a:endParaRPr lang="zh-CN" altLang="en-US" sz="1100" dirty="0"/>
          </a:p>
        </p:txBody>
      </p:sp>
      <p:sp>
        <p:nvSpPr>
          <p:cNvPr id="7" name="TextBox 6"/>
          <p:cNvSpPr txBox="1"/>
          <p:nvPr/>
        </p:nvSpPr>
        <p:spPr>
          <a:xfrm>
            <a:off x="4441876" y="2243693"/>
            <a:ext cx="9361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Figure 1C β-actin</a:t>
            </a:r>
            <a:endParaRPr lang="zh-CN" altLang="en-US" sz="1100" dirty="0"/>
          </a:p>
        </p:txBody>
      </p:sp>
      <p:cxnSp>
        <p:nvCxnSpPr>
          <p:cNvPr id="8" name="直接箭头连接符 7"/>
          <p:cNvCxnSpPr>
            <a:stCxn id="6" idx="1"/>
          </p:cNvCxnSpPr>
          <p:nvPr/>
        </p:nvCxnSpPr>
        <p:spPr>
          <a:xfrm flipH="1">
            <a:off x="3707904" y="857337"/>
            <a:ext cx="750740" cy="242764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/>
          <p:cNvCxnSpPr/>
          <p:nvPr/>
        </p:nvCxnSpPr>
        <p:spPr>
          <a:xfrm flipH="1">
            <a:off x="3756853" y="2459137"/>
            <a:ext cx="685023" cy="104131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3" descr="C:\Users\alice\Desktop\纤维化数据整理\2013-8-20-P-SMAD  FIGURE1D FIGURE1F\collagen &amp; marker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26" t="16710" r="4000" b="67520"/>
          <a:stretch/>
        </p:blipFill>
        <p:spPr bwMode="auto">
          <a:xfrm>
            <a:off x="5631826" y="4045139"/>
            <a:ext cx="3188646" cy="4518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1" name="直接箭头连接符 10"/>
          <p:cNvCxnSpPr/>
          <p:nvPr/>
        </p:nvCxnSpPr>
        <p:spPr>
          <a:xfrm flipH="1">
            <a:off x="2195738" y="4581127"/>
            <a:ext cx="3672406" cy="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441876" y="4066055"/>
            <a:ext cx="9361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Figure 1D  collagen Iα1</a:t>
            </a:r>
            <a:endParaRPr lang="zh-CN" altLang="en-US" sz="1100" dirty="0"/>
          </a:p>
        </p:txBody>
      </p:sp>
      <p:sp>
        <p:nvSpPr>
          <p:cNvPr id="13" name="TextBox 12"/>
          <p:cNvSpPr txBox="1"/>
          <p:nvPr/>
        </p:nvSpPr>
        <p:spPr>
          <a:xfrm>
            <a:off x="4527993" y="5185452"/>
            <a:ext cx="8158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Figure 1D β-actin</a:t>
            </a:r>
            <a:endParaRPr lang="zh-CN" altLang="en-US" sz="1100" dirty="0"/>
          </a:p>
        </p:txBody>
      </p:sp>
      <p:cxnSp>
        <p:nvCxnSpPr>
          <p:cNvPr id="14" name="直接箭头连接符 13"/>
          <p:cNvCxnSpPr/>
          <p:nvPr/>
        </p:nvCxnSpPr>
        <p:spPr>
          <a:xfrm flipH="1" flipV="1">
            <a:off x="2195737" y="4797153"/>
            <a:ext cx="3600399" cy="89038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2" descr="C:\Users\alice\Desktop\纤维化数据整理\2013-8-13 FIGURE1D ACTIN\CRCCHEMIDOC 2013-08-13 15 时 43 分_Exposure_4.0sec actin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80" t="22632" r="10818" b="32343"/>
          <a:stretch/>
        </p:blipFill>
        <p:spPr bwMode="auto">
          <a:xfrm>
            <a:off x="5580112" y="5013176"/>
            <a:ext cx="3412048" cy="7062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圆角矩形 23"/>
          <p:cNvSpPr/>
          <p:nvPr/>
        </p:nvSpPr>
        <p:spPr>
          <a:xfrm>
            <a:off x="1187624" y="4714062"/>
            <a:ext cx="900100" cy="166180"/>
          </a:xfrm>
          <a:prstGeom prst="round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圆角矩形 23"/>
          <p:cNvSpPr/>
          <p:nvPr/>
        </p:nvSpPr>
        <p:spPr>
          <a:xfrm>
            <a:off x="5868144" y="4880243"/>
            <a:ext cx="864096" cy="853014"/>
          </a:xfrm>
          <a:prstGeom prst="round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圆角矩形 23"/>
          <p:cNvSpPr/>
          <p:nvPr/>
        </p:nvSpPr>
        <p:spPr>
          <a:xfrm>
            <a:off x="6012160" y="3861048"/>
            <a:ext cx="733772" cy="742939"/>
          </a:xfrm>
          <a:prstGeom prst="round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圆角矩形 23"/>
          <p:cNvSpPr/>
          <p:nvPr/>
        </p:nvSpPr>
        <p:spPr>
          <a:xfrm>
            <a:off x="1168588" y="3417362"/>
            <a:ext cx="2537368" cy="227661"/>
          </a:xfrm>
          <a:prstGeom prst="round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圆角矩形 23"/>
          <p:cNvSpPr/>
          <p:nvPr/>
        </p:nvSpPr>
        <p:spPr>
          <a:xfrm>
            <a:off x="2856753" y="1065548"/>
            <a:ext cx="900100" cy="651532"/>
          </a:xfrm>
          <a:prstGeom prst="round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圆角矩形 23"/>
          <p:cNvSpPr/>
          <p:nvPr/>
        </p:nvSpPr>
        <p:spPr>
          <a:xfrm>
            <a:off x="2869492" y="3789040"/>
            <a:ext cx="900100" cy="684076"/>
          </a:xfrm>
          <a:prstGeom prst="round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TextBox 23"/>
          <p:cNvSpPr txBox="1"/>
          <p:nvPr/>
        </p:nvSpPr>
        <p:spPr>
          <a:xfrm>
            <a:off x="2890080" y="735619"/>
            <a:ext cx="815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solidFill>
                  <a:srgbClr val="FF0000"/>
                </a:solidFill>
              </a:rPr>
              <a:t>Revised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07504" y="3413348"/>
            <a:ext cx="815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solidFill>
                  <a:srgbClr val="FF0000"/>
                </a:solidFill>
              </a:rPr>
              <a:t>Revised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71748" y="4880238"/>
            <a:ext cx="815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solidFill>
                  <a:srgbClr val="FF0000"/>
                </a:solidFill>
              </a:rPr>
              <a:t>Revised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712117" y="3804445"/>
            <a:ext cx="815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solidFill>
                  <a:srgbClr val="FF0000"/>
                </a:solidFill>
              </a:rPr>
              <a:t>Revised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862754" y="157836"/>
            <a:ext cx="9361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Raw data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902572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</TotalTime>
  <Words>157</Words>
  <Application>Microsoft Office PowerPoint</Application>
  <PresentationFormat>On-screen Show (4:3)</PresentationFormat>
  <Paragraphs>5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宋体</vt:lpstr>
      <vt:lpstr>Arial</vt:lpstr>
      <vt:lpstr>Calibri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lice</dc:creator>
  <cp:lastModifiedBy>Kallie Huss</cp:lastModifiedBy>
  <cp:revision>14</cp:revision>
  <dcterms:created xsi:type="dcterms:W3CDTF">2014-09-02T02:03:32Z</dcterms:created>
  <dcterms:modified xsi:type="dcterms:W3CDTF">2015-11-06T19:50:28Z</dcterms:modified>
</cp:coreProperties>
</file>